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DEF70-442B-4A1E-8593-A8A7031D0C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6FBC5E-A39F-426E-B577-1E73CB8B08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BB623-DD49-4955-9652-FBA133AC58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BDD1D2-62EE-4347-BE3F-762704A413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CB1E7-1858-41F6-8690-03A033CE5A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4F58F-E6B7-49A1-9986-1360C7BCDA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38228D-2687-403A-A75E-358162B19D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8A6A3-1855-41FE-9271-856D0A1B21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67688-42FF-43FA-9AE4-1E81867794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C7837-9F69-4ED1-B9D0-F5D17BAA07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E0871-07F1-4A98-8109-BC9ECF0C0C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9B707-E5CA-44C6-9133-36D024919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1E20BBB-0F52-4A49-8132-0B75839DD832}" type="datetime"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3C73B03-CD11-4FCC-A56C-06E6D88295A9}" type="slidenum"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2646360" y="2503440"/>
            <a:ext cx="236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HEMOATTRACT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048"/>
          <p:cNvSpPr/>
          <p:nvPr/>
        </p:nvSpPr>
        <p:spPr>
          <a:xfrm>
            <a:off x="282600" y="3492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048"/>
          <p:cNvSpPr/>
          <p:nvPr/>
        </p:nvSpPr>
        <p:spPr>
          <a:xfrm>
            <a:off x="282600" y="290664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Agrupar 3"/>
          <p:cNvGrpSpPr/>
          <p:nvPr/>
        </p:nvGrpSpPr>
        <p:grpSpPr>
          <a:xfrm>
            <a:off x="655560" y="2906640"/>
            <a:ext cx="5384880" cy="3722400"/>
            <a:chOff x="655560" y="2906640"/>
            <a:chExt cx="5384880" cy="3722400"/>
          </a:xfrm>
        </p:grpSpPr>
        <p:grpSp>
          <p:nvGrpSpPr>
            <p:cNvPr id="45" name="Agrupar 29"/>
            <p:cNvGrpSpPr/>
            <p:nvPr/>
          </p:nvGrpSpPr>
          <p:grpSpPr>
            <a:xfrm>
              <a:off x="1806840" y="4499640"/>
              <a:ext cx="2882160" cy="2129400"/>
              <a:chOff x="1806840" y="4499640"/>
              <a:chExt cx="2882160" cy="2129400"/>
            </a:xfrm>
          </p:grpSpPr>
          <p:pic>
            <p:nvPicPr>
              <p:cNvPr id="46" name="Imagen 22" descr=""/>
              <p:cNvPicPr/>
              <p:nvPr/>
            </p:nvPicPr>
            <p:blipFill>
              <a:blip r:embed="rId1"/>
              <a:stretch/>
            </p:blipFill>
            <p:spPr>
              <a:xfrm>
                <a:off x="2068200" y="4973400"/>
                <a:ext cx="2364480" cy="1568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Box 11"/>
              <p:cNvSpPr/>
              <p:nvPr/>
            </p:nvSpPr>
            <p:spPr>
              <a:xfrm rot="16200000">
                <a:off x="921600" y="5384520"/>
                <a:ext cx="2016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ean relative velocity (a.u.)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ángulo 25"/>
              <p:cNvSpPr/>
              <p:nvPr/>
            </p:nvSpPr>
            <p:spPr>
              <a:xfrm>
                <a:off x="2933280" y="6413760"/>
                <a:ext cx="657000" cy="144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Box 11"/>
              <p:cNvSpPr/>
              <p:nvPr/>
            </p:nvSpPr>
            <p:spPr>
              <a:xfrm>
                <a:off x="2860560" y="6352560"/>
                <a:ext cx="1111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 in frames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Box 11"/>
              <p:cNvSpPr/>
              <p:nvPr/>
            </p:nvSpPr>
            <p:spPr>
              <a:xfrm>
                <a:off x="3912480" y="5261400"/>
                <a:ext cx="748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WIP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+/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Box 11"/>
              <p:cNvSpPr/>
              <p:nvPr/>
            </p:nvSpPr>
            <p:spPr>
              <a:xfrm>
                <a:off x="3940920" y="5837400"/>
                <a:ext cx="748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WIP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-/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2" name="Picture 12" descr="velocity profiles wt"/>
            <p:cNvPicPr/>
            <p:nvPr/>
          </p:nvPicPr>
          <p:blipFill>
            <a:blip r:embed="rId2"/>
            <a:stretch/>
          </p:blipFill>
          <p:spPr>
            <a:xfrm>
              <a:off x="1026360" y="3292200"/>
              <a:ext cx="2424600" cy="140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3" descr="velocity profiles ko"/>
            <p:cNvPicPr/>
            <p:nvPr/>
          </p:nvPicPr>
          <p:blipFill>
            <a:blip r:embed="rId3"/>
            <a:stretch/>
          </p:blipFill>
          <p:spPr>
            <a:xfrm>
              <a:off x="3619080" y="3255840"/>
              <a:ext cx="242136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Straight Connector 5"/>
            <p:cNvSpPr/>
            <p:nvPr/>
          </p:nvSpPr>
          <p:spPr>
            <a:xfrm>
              <a:off x="1196640" y="3182760"/>
              <a:ext cx="2200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Straight Connector 8"/>
            <p:cNvSpPr/>
            <p:nvPr/>
          </p:nvSpPr>
          <p:spPr>
            <a:xfrm>
              <a:off x="3787920" y="3182760"/>
              <a:ext cx="2200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10"/>
            <p:cNvSpPr/>
            <p:nvPr/>
          </p:nvSpPr>
          <p:spPr>
            <a:xfrm flipH="1">
              <a:off x="947520" y="3328920"/>
              <a:ext cx="1440" cy="122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1"/>
            <p:cNvSpPr/>
            <p:nvPr/>
          </p:nvSpPr>
          <p:spPr>
            <a:xfrm rot="16200000">
              <a:off x="16920" y="3697560"/>
              <a:ext cx="152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locity profiles (a.u.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1"/>
            <p:cNvSpPr/>
            <p:nvPr/>
          </p:nvSpPr>
          <p:spPr>
            <a:xfrm>
              <a:off x="2028240" y="290664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+/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1"/>
            <p:cNvSpPr/>
            <p:nvPr/>
          </p:nvSpPr>
          <p:spPr>
            <a:xfrm>
              <a:off x="4592520" y="2906640"/>
              <a:ext cx="60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Agrupar 2"/>
          <p:cNvGrpSpPr/>
          <p:nvPr/>
        </p:nvGrpSpPr>
        <p:grpSpPr>
          <a:xfrm>
            <a:off x="498600" y="50760"/>
            <a:ext cx="5670360" cy="2438280"/>
            <a:chOff x="498600" y="50760"/>
            <a:chExt cx="5670360" cy="2438280"/>
          </a:xfrm>
        </p:grpSpPr>
        <p:pic>
          <p:nvPicPr>
            <p:cNvPr id="61" name="Picture 9" descr="fib wt dots"/>
            <p:cNvPicPr/>
            <p:nvPr/>
          </p:nvPicPr>
          <p:blipFill>
            <a:blip r:embed="rId4"/>
            <a:stretch/>
          </p:blipFill>
          <p:spPr>
            <a:xfrm>
              <a:off x="498600" y="384840"/>
              <a:ext cx="2546280" cy="210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10" descr="fib ko dots"/>
            <p:cNvPicPr/>
            <p:nvPr/>
          </p:nvPicPr>
          <p:blipFill>
            <a:blip r:embed="rId5"/>
            <a:stretch/>
          </p:blipFill>
          <p:spPr>
            <a:xfrm>
              <a:off x="3622680" y="364320"/>
              <a:ext cx="2546280" cy="2124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Rectangle 5"/>
            <p:cNvSpPr/>
            <p:nvPr/>
          </p:nvSpPr>
          <p:spPr>
            <a:xfrm>
              <a:off x="4502160" y="50760"/>
              <a:ext cx="106668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6"/>
            <p:cNvSpPr/>
            <p:nvPr/>
          </p:nvSpPr>
          <p:spPr>
            <a:xfrm>
              <a:off x="1022400" y="50760"/>
              <a:ext cx="167616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7"/>
            <p:cNvSpPr/>
            <p:nvPr/>
          </p:nvSpPr>
          <p:spPr>
            <a:xfrm>
              <a:off x="716040" y="366480"/>
              <a:ext cx="2268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Straight Connector 9"/>
            <p:cNvSpPr/>
            <p:nvPr/>
          </p:nvSpPr>
          <p:spPr>
            <a:xfrm>
              <a:off x="3849840" y="366480"/>
              <a:ext cx="22669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11"/>
            <p:cNvSpPr/>
            <p:nvPr/>
          </p:nvSpPr>
          <p:spPr>
            <a:xfrm>
              <a:off x="1581120" y="7524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+/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11"/>
            <p:cNvSpPr/>
            <p:nvPr/>
          </p:nvSpPr>
          <p:spPr>
            <a:xfrm>
              <a:off x="4748400" y="91080"/>
              <a:ext cx="60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Agrupar 43"/>
          <p:cNvGrpSpPr/>
          <p:nvPr/>
        </p:nvGrpSpPr>
        <p:grpSpPr>
          <a:xfrm>
            <a:off x="660240" y="6629400"/>
            <a:ext cx="5362560" cy="1974960"/>
            <a:chOff x="660240" y="6629400"/>
            <a:chExt cx="5362560" cy="1974960"/>
          </a:xfrm>
        </p:grpSpPr>
        <p:pic>
          <p:nvPicPr>
            <p:cNvPr id="70" name="Picture 10" descr="persistance profiles wt"/>
            <p:cNvPicPr/>
            <p:nvPr/>
          </p:nvPicPr>
          <p:blipFill>
            <a:blip r:embed="rId6"/>
            <a:stretch/>
          </p:blipFill>
          <p:spPr>
            <a:xfrm>
              <a:off x="1007640" y="7219800"/>
              <a:ext cx="2468520" cy="136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11" descr="persistence profiles ko"/>
            <p:cNvPicPr/>
            <p:nvPr/>
          </p:nvPicPr>
          <p:blipFill>
            <a:blip r:embed="rId7"/>
            <a:stretch/>
          </p:blipFill>
          <p:spPr>
            <a:xfrm>
              <a:off x="3547800" y="7219800"/>
              <a:ext cx="2475000" cy="136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TextBox 11"/>
            <p:cNvSpPr/>
            <p:nvPr/>
          </p:nvSpPr>
          <p:spPr>
            <a:xfrm rot="16200000">
              <a:off x="-203760" y="7493760"/>
              <a:ext cx="197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ersistence profiles (a.u.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Straight Connector 5"/>
            <p:cNvSpPr/>
            <p:nvPr/>
          </p:nvSpPr>
          <p:spPr>
            <a:xfrm>
              <a:off x="1152360" y="7135920"/>
              <a:ext cx="2200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8"/>
            <p:cNvSpPr/>
            <p:nvPr/>
          </p:nvSpPr>
          <p:spPr>
            <a:xfrm>
              <a:off x="3743280" y="7135920"/>
              <a:ext cx="2200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11"/>
            <p:cNvSpPr/>
            <p:nvPr/>
          </p:nvSpPr>
          <p:spPr>
            <a:xfrm>
              <a:off x="1984320" y="686088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+/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11"/>
            <p:cNvSpPr/>
            <p:nvPr/>
          </p:nvSpPr>
          <p:spPr>
            <a:xfrm>
              <a:off x="4548240" y="6860880"/>
              <a:ext cx="60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P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10"/>
            <p:cNvSpPr/>
            <p:nvPr/>
          </p:nvSpPr>
          <p:spPr>
            <a:xfrm flipH="1">
              <a:off x="939600" y="7243560"/>
              <a:ext cx="1440" cy="122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Rectangle 1048"/>
          <p:cNvSpPr/>
          <p:nvPr/>
        </p:nvSpPr>
        <p:spPr>
          <a:xfrm>
            <a:off x="282600" y="6846840"/>
            <a:ext cx="55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30T17:30:06Z</dcterms:created>
  <dc:creator>Inma</dc:creator>
  <dc:description/>
  <dc:language>en-US</dc:language>
  <cp:lastModifiedBy>Osara anton</cp:lastModifiedBy>
  <cp:lastPrinted>2012-09-06T15:48:22Z</cp:lastPrinted>
  <dcterms:modified xsi:type="dcterms:W3CDTF">2013-07-17T15:06:59Z</dcterms:modified>
  <cp:revision>22</cp:revision>
  <dc:subject/>
  <dc:title>Slide 1</dc:title>
</cp:coreProperties>
</file>